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389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066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431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043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522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962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349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541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206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54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772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B7E338-14FE-466D-A13A-669F17FC420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067821-FEEE-4338-A233-D295F592E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69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2968" y="689811"/>
            <a:ext cx="8926028" cy="4985485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490134" y="584200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24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nM) for biquinolines against sensitive strain D6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8193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7:17Z</dcterms:created>
  <dcterms:modified xsi:type="dcterms:W3CDTF">2020-08-04T16:36:14Z</dcterms:modified>
</cp:coreProperties>
</file>